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75BCE7F-20AD-40F7-8E3C-4F8124CA6ADE}" v="4" dt="2023-09-12T09:41:29.58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361"/>
    <p:restoredTop sz="94674"/>
  </p:normalViewPr>
  <p:slideViewPr>
    <p:cSldViewPr snapToGrid="0">
      <p:cViewPr varScale="1">
        <p:scale>
          <a:sx n="62" d="100"/>
          <a:sy n="62" d="100"/>
        </p:scale>
        <p:origin x="816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iara Micoli" userId="0375788a-410b-4d5b-9359-a625b363f988" providerId="ADAL" clId="{3ED678BF-F254-4404-949D-ABD4D1547DB1}"/>
    <pc:docChg chg="modSld">
      <pc:chgData name="Chiara Micoli" userId="0375788a-410b-4d5b-9359-a625b363f988" providerId="ADAL" clId="{3ED678BF-F254-4404-949D-ABD4D1547DB1}" dt="2023-09-01T07:11:45.520" v="2" actId="20577"/>
      <pc:docMkLst>
        <pc:docMk/>
      </pc:docMkLst>
      <pc:sldChg chg="modSp mod">
        <pc:chgData name="Chiara Micoli" userId="0375788a-410b-4d5b-9359-a625b363f988" providerId="ADAL" clId="{3ED678BF-F254-4404-949D-ABD4D1547DB1}" dt="2023-09-01T07:11:45.520" v="2" actId="20577"/>
        <pc:sldMkLst>
          <pc:docMk/>
          <pc:sldMk cId="2258387745" sldId="256"/>
        </pc:sldMkLst>
        <pc:spChg chg="mod">
          <ac:chgData name="Chiara Micoli" userId="0375788a-410b-4d5b-9359-a625b363f988" providerId="ADAL" clId="{3ED678BF-F254-4404-949D-ABD4D1547DB1}" dt="2023-09-01T07:11:45.520" v="2" actId="20577"/>
          <ac:spMkLst>
            <pc:docMk/>
            <pc:sldMk cId="2258387745" sldId="256"/>
            <ac:spMk id="15" creationId="{075DD9F4-34DA-6F75-5401-9EACB4926329}"/>
          </ac:spMkLst>
        </pc:spChg>
      </pc:sldChg>
    </pc:docChg>
  </pc:docChgLst>
  <pc:docChgLst>
    <pc:chgData name="Chiara Micoli" userId="0375788a-410b-4d5b-9359-a625b363f988" providerId="ADAL" clId="{02F852AC-5C05-4D2B-99F9-F90DC08C0D1D}"/>
    <pc:docChg chg="undo custSel addSld delSld modSld">
      <pc:chgData name="Chiara Micoli" userId="0375788a-410b-4d5b-9359-a625b363f988" providerId="ADAL" clId="{02F852AC-5C05-4D2B-99F9-F90DC08C0D1D}" dt="2023-07-18T21:30:42.271" v="723" actId="20577"/>
      <pc:docMkLst>
        <pc:docMk/>
      </pc:docMkLst>
      <pc:sldChg chg="addSp delSp modSp mod">
        <pc:chgData name="Chiara Micoli" userId="0375788a-410b-4d5b-9359-a625b363f988" providerId="ADAL" clId="{02F852AC-5C05-4D2B-99F9-F90DC08C0D1D}" dt="2023-07-18T21:28:51.354" v="635" actId="20577"/>
        <pc:sldMkLst>
          <pc:docMk/>
          <pc:sldMk cId="2258387745" sldId="256"/>
        </pc:sldMkLst>
        <pc:spChg chg="mod">
          <ac:chgData name="Chiara Micoli" userId="0375788a-410b-4d5b-9359-a625b363f988" providerId="ADAL" clId="{02F852AC-5C05-4D2B-99F9-F90DC08C0D1D}" dt="2023-07-18T21:12:48.730" v="459" actId="404"/>
          <ac:spMkLst>
            <pc:docMk/>
            <pc:sldMk cId="2258387745" sldId="256"/>
            <ac:spMk id="4" creationId="{0AEDBE2C-0AAC-BA12-DE31-1173140E1612}"/>
          </ac:spMkLst>
        </pc:spChg>
        <pc:spChg chg="mod">
          <ac:chgData name="Chiara Micoli" userId="0375788a-410b-4d5b-9359-a625b363f988" providerId="ADAL" clId="{02F852AC-5C05-4D2B-99F9-F90DC08C0D1D}" dt="2023-07-18T21:16:56.878" v="576" actId="20577"/>
          <ac:spMkLst>
            <pc:docMk/>
            <pc:sldMk cId="2258387745" sldId="256"/>
            <ac:spMk id="5" creationId="{0B2E8CAD-C699-D36B-6DD4-50DA068C4D1F}"/>
          </ac:spMkLst>
        </pc:spChg>
        <pc:spChg chg="add del mod">
          <ac:chgData name="Chiara Micoli" userId="0375788a-410b-4d5b-9359-a625b363f988" providerId="ADAL" clId="{02F852AC-5C05-4D2B-99F9-F90DC08C0D1D}" dt="2023-07-18T21:07:43.183" v="251"/>
          <ac:spMkLst>
            <pc:docMk/>
            <pc:sldMk cId="2258387745" sldId="256"/>
            <ac:spMk id="6" creationId="{E34A3FE1-4D95-CC21-7FA3-FA35F2C1A9DC}"/>
          </ac:spMkLst>
        </pc:spChg>
        <pc:spChg chg="mod">
          <ac:chgData name="Chiara Micoli" userId="0375788a-410b-4d5b-9359-a625b363f988" providerId="ADAL" clId="{02F852AC-5C05-4D2B-99F9-F90DC08C0D1D}" dt="2023-07-18T21:19:46.365" v="579" actId="20577"/>
          <ac:spMkLst>
            <pc:docMk/>
            <pc:sldMk cId="2258387745" sldId="256"/>
            <ac:spMk id="7" creationId="{A9817430-B435-FAC7-B89B-CE6EC57096D2}"/>
          </ac:spMkLst>
        </pc:spChg>
        <pc:spChg chg="add del mod">
          <ac:chgData name="Chiara Micoli" userId="0375788a-410b-4d5b-9359-a625b363f988" providerId="ADAL" clId="{02F852AC-5C05-4D2B-99F9-F90DC08C0D1D}" dt="2023-07-18T21:07:43.183" v="251"/>
          <ac:spMkLst>
            <pc:docMk/>
            <pc:sldMk cId="2258387745" sldId="256"/>
            <ac:spMk id="8" creationId="{DF6216D3-AB96-34AD-5A84-DBC4C4BCFF4B}"/>
          </ac:spMkLst>
        </pc:spChg>
        <pc:spChg chg="mod">
          <ac:chgData name="Chiara Micoli" userId="0375788a-410b-4d5b-9359-a625b363f988" providerId="ADAL" clId="{02F852AC-5C05-4D2B-99F9-F90DC08C0D1D}" dt="2023-07-18T21:13:41.704" v="461" actId="1076"/>
          <ac:spMkLst>
            <pc:docMk/>
            <pc:sldMk cId="2258387745" sldId="256"/>
            <ac:spMk id="10" creationId="{D5F743CC-CEE8-7C56-92A2-80D3F84B5478}"/>
          </ac:spMkLst>
        </pc:spChg>
        <pc:spChg chg="mod">
          <ac:chgData name="Chiara Micoli" userId="0375788a-410b-4d5b-9359-a625b363f988" providerId="ADAL" clId="{02F852AC-5C05-4D2B-99F9-F90DC08C0D1D}" dt="2023-07-18T21:13:50.175" v="462" actId="1076"/>
          <ac:spMkLst>
            <pc:docMk/>
            <pc:sldMk cId="2258387745" sldId="256"/>
            <ac:spMk id="11" creationId="{F2EF5436-6355-1566-BCC0-F0511E161D21}"/>
          </ac:spMkLst>
        </pc:spChg>
        <pc:spChg chg="add mod">
          <ac:chgData name="Chiara Micoli" userId="0375788a-410b-4d5b-9359-a625b363f988" providerId="ADAL" clId="{02F852AC-5C05-4D2B-99F9-F90DC08C0D1D}" dt="2023-07-18T21:28:51.354" v="635" actId="20577"/>
          <ac:spMkLst>
            <pc:docMk/>
            <pc:sldMk cId="2258387745" sldId="256"/>
            <ac:spMk id="15" creationId="{075DD9F4-34DA-6F75-5401-9EACB4926329}"/>
          </ac:spMkLst>
        </pc:spChg>
        <pc:spChg chg="add mod">
          <ac:chgData name="Chiara Micoli" userId="0375788a-410b-4d5b-9359-a625b363f988" providerId="ADAL" clId="{02F852AC-5C05-4D2B-99F9-F90DC08C0D1D}" dt="2023-07-18T21:16:21.440" v="561" actId="20577"/>
          <ac:spMkLst>
            <pc:docMk/>
            <pc:sldMk cId="2258387745" sldId="256"/>
            <ac:spMk id="17" creationId="{1790D78A-8C33-D73F-5D69-94E29987A167}"/>
          </ac:spMkLst>
        </pc:spChg>
        <pc:cxnChg chg="mod">
          <ac:chgData name="Chiara Micoli" userId="0375788a-410b-4d5b-9359-a625b363f988" providerId="ADAL" clId="{02F852AC-5C05-4D2B-99F9-F90DC08C0D1D}" dt="2023-07-18T21:15:46.207" v="500" actId="21"/>
          <ac:cxnSpMkLst>
            <pc:docMk/>
            <pc:sldMk cId="2258387745" sldId="256"/>
            <ac:cxnSpMk id="9" creationId="{F009D45A-DE48-B86D-293D-FEC26E817C5E}"/>
          </ac:cxnSpMkLst>
        </pc:cxnChg>
        <pc:cxnChg chg="add del mod">
          <ac:chgData name="Chiara Micoli" userId="0375788a-410b-4d5b-9359-a625b363f988" providerId="ADAL" clId="{02F852AC-5C05-4D2B-99F9-F90DC08C0D1D}" dt="2023-07-18T21:07:43.183" v="251"/>
          <ac:cxnSpMkLst>
            <pc:docMk/>
            <pc:sldMk cId="2258387745" sldId="256"/>
            <ac:cxnSpMk id="12" creationId="{3A5B3035-3A37-C9BD-138C-0755494071AB}"/>
          </ac:cxnSpMkLst>
        </pc:cxnChg>
        <pc:cxnChg chg="mod">
          <ac:chgData name="Chiara Micoli" userId="0375788a-410b-4d5b-9359-a625b363f988" providerId="ADAL" clId="{02F852AC-5C05-4D2B-99F9-F90DC08C0D1D}" dt="2023-07-18T21:15:46.207" v="500" actId="21"/>
          <ac:cxnSpMkLst>
            <pc:docMk/>
            <pc:sldMk cId="2258387745" sldId="256"/>
            <ac:cxnSpMk id="13" creationId="{0893A239-4276-0772-6387-B7F2AD971210}"/>
          </ac:cxnSpMkLst>
        </pc:cxnChg>
        <pc:cxnChg chg="add del mod">
          <ac:chgData name="Chiara Micoli" userId="0375788a-410b-4d5b-9359-a625b363f988" providerId="ADAL" clId="{02F852AC-5C05-4D2B-99F9-F90DC08C0D1D}" dt="2023-07-18T21:07:43.183" v="251"/>
          <ac:cxnSpMkLst>
            <pc:docMk/>
            <pc:sldMk cId="2258387745" sldId="256"/>
            <ac:cxnSpMk id="14" creationId="{D2129989-6752-8DEC-FD4D-E9DEBEBC9AAB}"/>
          </ac:cxnSpMkLst>
        </pc:cxnChg>
        <pc:cxnChg chg="mod">
          <ac:chgData name="Chiara Micoli" userId="0375788a-410b-4d5b-9359-a625b363f988" providerId="ADAL" clId="{02F852AC-5C05-4D2B-99F9-F90DC08C0D1D}" dt="2023-07-18T21:13:41.704" v="461" actId="1076"/>
          <ac:cxnSpMkLst>
            <pc:docMk/>
            <pc:sldMk cId="2258387745" sldId="256"/>
            <ac:cxnSpMk id="16" creationId="{21A92125-2594-F1D2-CDA5-AA36C258E3EF}"/>
          </ac:cxnSpMkLst>
        </pc:cxnChg>
        <pc:cxnChg chg="add mod">
          <ac:chgData name="Chiara Micoli" userId="0375788a-410b-4d5b-9359-a625b363f988" providerId="ADAL" clId="{02F852AC-5C05-4D2B-99F9-F90DC08C0D1D}" dt="2023-07-18T21:16:02.481" v="515" actId="20577"/>
          <ac:cxnSpMkLst>
            <pc:docMk/>
            <pc:sldMk cId="2258387745" sldId="256"/>
            <ac:cxnSpMk id="18" creationId="{CA9C0019-8A8F-D898-68B8-B893EF6AC0ED}"/>
          </ac:cxnSpMkLst>
        </pc:cxnChg>
        <pc:cxnChg chg="mod">
          <ac:chgData name="Chiara Micoli" userId="0375788a-410b-4d5b-9359-a625b363f988" providerId="ADAL" clId="{02F852AC-5C05-4D2B-99F9-F90DC08C0D1D}" dt="2023-07-18T21:13:41.704" v="461" actId="1076"/>
          <ac:cxnSpMkLst>
            <pc:docMk/>
            <pc:sldMk cId="2258387745" sldId="256"/>
            <ac:cxnSpMk id="19" creationId="{19B25D95-CA0F-09E1-B29F-2F0204A10D2C}"/>
          </ac:cxnSpMkLst>
        </pc:cxnChg>
        <pc:cxnChg chg="add mod">
          <ac:chgData name="Chiara Micoli" userId="0375788a-410b-4d5b-9359-a625b363f988" providerId="ADAL" clId="{02F852AC-5C05-4D2B-99F9-F90DC08C0D1D}" dt="2023-07-18T21:12:56.478" v="460" actId="1076"/>
          <ac:cxnSpMkLst>
            <pc:docMk/>
            <pc:sldMk cId="2258387745" sldId="256"/>
            <ac:cxnSpMk id="20" creationId="{BB7B542D-0460-3880-C5D7-EDB49F8D7574}"/>
          </ac:cxnSpMkLst>
        </pc:cxnChg>
      </pc:sldChg>
      <pc:sldChg chg="addSp modSp add mod">
        <pc:chgData name="Chiara Micoli" userId="0375788a-410b-4d5b-9359-a625b363f988" providerId="ADAL" clId="{02F852AC-5C05-4D2B-99F9-F90DC08C0D1D}" dt="2023-07-18T21:30:42.271" v="723" actId="20577"/>
        <pc:sldMkLst>
          <pc:docMk/>
          <pc:sldMk cId="17694287" sldId="257"/>
        </pc:sldMkLst>
        <pc:spChg chg="add mod">
          <ac:chgData name="Chiara Micoli" userId="0375788a-410b-4d5b-9359-a625b363f988" providerId="ADAL" clId="{02F852AC-5C05-4D2B-99F9-F90DC08C0D1D}" dt="2023-07-18T21:30:42.271" v="723" actId="20577"/>
          <ac:spMkLst>
            <pc:docMk/>
            <pc:sldMk cId="17694287" sldId="257"/>
            <ac:spMk id="2" creationId="{5F83AE24-2021-8454-A6F0-C7F5B7DA117D}"/>
          </ac:spMkLst>
        </pc:spChg>
        <pc:spChg chg="mod">
          <ac:chgData name="Chiara Micoli" userId="0375788a-410b-4d5b-9359-a625b363f988" providerId="ADAL" clId="{02F852AC-5C05-4D2B-99F9-F90DC08C0D1D}" dt="2023-07-18T21:29:08.758" v="650" actId="20577"/>
          <ac:spMkLst>
            <pc:docMk/>
            <pc:sldMk cId="17694287" sldId="257"/>
            <ac:spMk id="10" creationId="{D5F743CC-CEE8-7C56-92A2-80D3F84B5478}"/>
          </ac:spMkLst>
        </pc:spChg>
        <pc:spChg chg="mod">
          <ac:chgData name="Chiara Micoli" userId="0375788a-410b-4d5b-9359-a625b363f988" providerId="ADAL" clId="{02F852AC-5C05-4D2B-99F9-F90DC08C0D1D}" dt="2023-07-18T21:30:26.436" v="694" actId="14100"/>
          <ac:spMkLst>
            <pc:docMk/>
            <pc:sldMk cId="17694287" sldId="257"/>
            <ac:spMk id="11" creationId="{F2EF5436-6355-1566-BCC0-F0511E161D21}"/>
          </ac:spMkLst>
        </pc:spChg>
        <pc:spChg chg="mod">
          <ac:chgData name="Chiara Micoli" userId="0375788a-410b-4d5b-9359-a625b363f988" providerId="ADAL" clId="{02F852AC-5C05-4D2B-99F9-F90DC08C0D1D}" dt="2023-07-18T21:29:43.724" v="669" actId="20577"/>
          <ac:spMkLst>
            <pc:docMk/>
            <pc:sldMk cId="17694287" sldId="257"/>
            <ac:spMk id="15" creationId="{075DD9F4-34DA-6F75-5401-9EACB4926329}"/>
          </ac:spMkLst>
        </pc:spChg>
        <pc:cxnChg chg="add mod">
          <ac:chgData name="Chiara Micoli" userId="0375788a-410b-4d5b-9359-a625b363f988" providerId="ADAL" clId="{02F852AC-5C05-4D2B-99F9-F90DC08C0D1D}" dt="2023-07-18T21:29:58.537" v="671" actId="1076"/>
          <ac:cxnSpMkLst>
            <pc:docMk/>
            <pc:sldMk cId="17694287" sldId="257"/>
            <ac:cxnSpMk id="3" creationId="{E58397D1-8131-FF59-BD81-2CBE28D8C056}"/>
          </ac:cxnSpMkLst>
        </pc:cxnChg>
      </pc:sldChg>
      <pc:sldChg chg="addSp delSp modSp new del mod">
        <pc:chgData name="Chiara Micoli" userId="0375788a-410b-4d5b-9359-a625b363f988" providerId="ADAL" clId="{02F852AC-5C05-4D2B-99F9-F90DC08C0D1D}" dt="2023-07-18T21:17:02.410" v="577" actId="47"/>
        <pc:sldMkLst>
          <pc:docMk/>
          <pc:sldMk cId="3057247220" sldId="257"/>
        </pc:sldMkLst>
        <pc:graphicFrameChg chg="add mod modGraphic">
          <ac:chgData name="Chiara Micoli" userId="0375788a-410b-4d5b-9359-a625b363f988" providerId="ADAL" clId="{02F852AC-5C05-4D2B-99F9-F90DC08C0D1D}" dt="2023-07-18T21:04:12.497" v="206" actId="20577"/>
          <ac:graphicFrameMkLst>
            <pc:docMk/>
            <pc:sldMk cId="3057247220" sldId="257"/>
            <ac:graphicFrameMk id="3" creationId="{7C40D465-1DAF-50EC-6F97-17F9A62D899C}"/>
          </ac:graphicFrameMkLst>
        </pc:graphicFrameChg>
        <pc:picChg chg="add del mod">
          <ac:chgData name="Chiara Micoli" userId="0375788a-410b-4d5b-9359-a625b363f988" providerId="ADAL" clId="{02F852AC-5C05-4D2B-99F9-F90DC08C0D1D}" dt="2023-07-18T20:52:23.096" v="2" actId="478"/>
          <ac:picMkLst>
            <pc:docMk/>
            <pc:sldMk cId="3057247220" sldId="257"/>
            <ac:picMk id="2" creationId="{8918A167-EB8E-7DFE-49F9-7994A8051A61}"/>
          </ac:picMkLst>
        </pc:picChg>
      </pc:sldChg>
    </pc:docChg>
  </pc:docChgLst>
  <pc:docChgLst>
    <pc:chgData name="Chiara Micoli" userId="0375788a-410b-4d5b-9359-a625b363f988" providerId="ADAL" clId="{375BCE7F-20AD-40F7-8E3C-4F8124CA6ADE}"/>
    <pc:docChg chg="custSel modSld">
      <pc:chgData name="Chiara Micoli" userId="0375788a-410b-4d5b-9359-a625b363f988" providerId="ADAL" clId="{375BCE7F-20AD-40F7-8E3C-4F8124CA6ADE}" dt="2023-09-12T09:41:36.927" v="48" actId="20577"/>
      <pc:docMkLst>
        <pc:docMk/>
      </pc:docMkLst>
      <pc:sldChg chg="addSp delSp modSp mod">
        <pc:chgData name="Chiara Micoli" userId="0375788a-410b-4d5b-9359-a625b363f988" providerId="ADAL" clId="{375BCE7F-20AD-40F7-8E3C-4F8124CA6ADE}" dt="2023-09-12T09:41:36.927" v="48" actId="20577"/>
        <pc:sldMkLst>
          <pc:docMk/>
          <pc:sldMk cId="2258387745" sldId="256"/>
        </pc:sldMkLst>
        <pc:spChg chg="add del">
          <ac:chgData name="Chiara Micoli" userId="0375788a-410b-4d5b-9359-a625b363f988" providerId="ADAL" clId="{375BCE7F-20AD-40F7-8E3C-4F8124CA6ADE}" dt="2023-09-12T09:41:25.449" v="39"/>
          <ac:spMkLst>
            <pc:docMk/>
            <pc:sldMk cId="2258387745" sldId="256"/>
            <ac:spMk id="2" creationId="{21CF5119-1ADE-5DF2-1F71-DBF3FA3EA5F5}"/>
          </ac:spMkLst>
        </pc:spChg>
        <pc:spChg chg="add del">
          <ac:chgData name="Chiara Micoli" userId="0375788a-410b-4d5b-9359-a625b363f988" providerId="ADAL" clId="{375BCE7F-20AD-40F7-8E3C-4F8124CA6ADE}" dt="2023-09-12T09:41:29.588" v="41"/>
          <ac:spMkLst>
            <pc:docMk/>
            <pc:sldMk cId="2258387745" sldId="256"/>
            <ac:spMk id="3" creationId="{FCE36B5D-5B5A-9719-C7E5-7C0D8EB7E602}"/>
          </ac:spMkLst>
        </pc:spChg>
        <pc:spChg chg="mod">
          <ac:chgData name="Chiara Micoli" userId="0375788a-410b-4d5b-9359-a625b363f988" providerId="ADAL" clId="{375BCE7F-20AD-40F7-8E3C-4F8124CA6ADE}" dt="2023-09-12T09:41:36.927" v="48" actId="20577"/>
          <ac:spMkLst>
            <pc:docMk/>
            <pc:sldMk cId="2258387745" sldId="256"/>
            <ac:spMk id="15" creationId="{075DD9F4-34DA-6F75-5401-9EACB4926329}"/>
          </ac:spMkLst>
        </pc:spChg>
        <pc:spChg chg="mod">
          <ac:chgData name="Chiara Micoli" userId="0375788a-410b-4d5b-9359-a625b363f988" providerId="ADAL" clId="{375BCE7F-20AD-40F7-8E3C-4F8124CA6ADE}" dt="2023-09-12T09:41:04.775" v="37" actId="20577"/>
          <ac:spMkLst>
            <pc:docMk/>
            <pc:sldMk cId="2258387745" sldId="256"/>
            <ac:spMk id="17" creationId="{1790D78A-8C33-D73F-5D69-94E29987A167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5953FED6-6302-BB03-E9B5-559CD899CE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  <a:endParaRPr lang="en-US"/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749412F0-265A-BBB9-A18F-AB4A52C11C2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  <a:endParaRPr lang="en-US"/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549400EF-57E2-6161-9C55-2084CF6712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38A1C-4EE2-8540-BEE7-A4AC78CA4A0A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EA2D8FAD-8AE8-83D2-648D-701E72DFC0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FC98C008-998C-6EC1-E320-9420F3796E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69892-CC1D-D042-B375-BB9394B36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77607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BAD70AB5-C7E5-CCD5-35FE-D0CF933F3A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/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5BB8CAEA-3A33-9CEC-B186-F92869C910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2C7DE2E2-74A9-24F9-A8F4-74628DCAF1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38A1C-4EE2-8540-BEE7-A4AC78CA4A0A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A655A2D2-2600-808F-092E-FEEF3727C1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015881BE-D002-9632-2915-110E047C9D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69892-CC1D-D042-B375-BB9394B36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6616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07005A11-86AD-DD2A-D14C-F0CA3C8EAED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  <a:endParaRPr lang="en-US"/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3AD35C67-2E1B-4EB9-144D-2DE335BA17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10570333-F604-6786-0B04-D4DF44348A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38A1C-4EE2-8540-BEE7-A4AC78CA4A0A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60381718-A105-859E-C49D-6DBDAED9EE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407F9365-54FC-85AC-DDE1-8EB6DDBDE0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69892-CC1D-D042-B375-BB9394B36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72212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A1C1B8F1-88E6-0589-A32D-6710E1F402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/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AC2426D8-0F4D-01AC-3B4F-772BC69EFD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99899DAA-742B-51DF-F866-413556FDCD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38A1C-4EE2-8540-BEE7-A4AC78CA4A0A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D43EEDEA-3356-7BFB-E033-391E0AF445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E461ADA6-B55A-8086-B373-4B01A83E08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69892-CC1D-D042-B375-BB9394B36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6479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0BB06B0B-CF92-09E8-3083-E566A9706D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  <a:endParaRPr lang="en-US"/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32700C70-CE76-3B0A-AC20-0433DB71BF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4C9C80ED-2325-143D-B10E-D14006B20A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38A1C-4EE2-8540-BEE7-A4AC78CA4A0A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19B4DE3A-7B97-8641-AA0F-F5EDCF18FA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BA198724-72FA-AF9B-1478-E906359843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69892-CC1D-D042-B375-BB9394B36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13829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DAF81DDC-5F5E-2A0E-892F-DC8E249DED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/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483DFEEE-6E86-FB32-E0DA-9F41F4CCA69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FEF3A19F-81F2-F7F9-6CAC-2F9F2624EE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9E1655F0-4CFA-2E26-B099-C13E1E6EFD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38A1C-4EE2-8540-BEE7-A4AC78CA4A0A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E7B21AAE-F96C-0A0B-C101-3A4B694C9B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695EA48C-99FA-0E98-C2C7-98E45E812F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69892-CC1D-D042-B375-BB9394B36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1123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C1CD3505-115C-5F88-88A8-F4FB489019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  <a:endParaRPr lang="en-US"/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3FDBBF00-3B77-E34D-E016-CC2B9FAE85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235038A1-CF53-C141-18B8-491E3CBC80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A82A9E09-3E59-2A0A-238A-89DAB43EFC6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5325C8B2-C295-53DC-85B3-3553FDB7390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9D77E7AF-FD3E-DEB8-18D2-ACBC38E0A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38A1C-4EE2-8540-BEE7-A4AC78CA4A0A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1200E097-E5ED-BB57-0D32-DED933D9B2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C3208F11-8342-5597-FC3D-9212B8FA77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69892-CC1D-D042-B375-BB9394B36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9522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2873B871-2B0F-CF72-33CF-7157BCF4FC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/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62CE8BDA-233D-D48D-699A-B8B47FDCF4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38A1C-4EE2-8540-BEE7-A4AC78CA4A0A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47DFECC8-560E-0968-E36C-4913D84F38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218C3A47-FA3A-320A-65E7-D7C5B0DC50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69892-CC1D-D042-B375-BB9394B36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076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C4772DD8-9876-10E7-DC38-8F7FBF5D45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38A1C-4EE2-8540-BEE7-A4AC78CA4A0A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585D41F4-4B8A-65AD-9952-FF80808870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39BFBF82-E611-891C-E850-5EFABA4FF3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69892-CC1D-D042-B375-BB9394B36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03592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0BF4F825-6203-F697-2767-3C3158594D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  <a:endParaRPr lang="en-US"/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A139A651-277B-C01C-4E45-C44893A069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18A3CCB5-079D-8465-A001-CF8E591B27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54FCA536-AA8D-654B-949A-4292B9EBD3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38A1C-4EE2-8540-BEE7-A4AC78CA4A0A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E8A80D91-F7A3-1C0C-168A-CDE8CBD066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F93D2271-A790-6F12-DE66-D99DAE4349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69892-CC1D-D042-B375-BB9394B36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070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8C4D500A-FAB1-4DD9-E37E-DAA528BB3E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  <a:endParaRPr lang="en-US"/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CBDD8E5D-20C6-9D0B-998B-58CB3AAC0BB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B267E280-64DA-3A3E-17C5-12719FB01C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DF752D24-E69A-8C2E-6DBD-9B0B334353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38A1C-4EE2-8540-BEE7-A4AC78CA4A0A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F8F2733D-76C3-9E8D-42B7-A135A3ABC3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CD95E014-A2F3-6ECB-6343-00124F2172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69892-CC1D-D042-B375-BB9394B36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3572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270EE2FE-99EE-245D-083D-23B40BEB4F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  <a:endParaRPr lang="en-US"/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7EB4EDBF-C337-46F3-C5F1-3CBD35AFDB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BC75B139-B001-A348-6BC9-DBEAB6DE230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138A1C-4EE2-8540-BEE7-A4AC78CA4A0A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552ABE52-246F-5C7F-AEF1-C2427CE9CDE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865E3D83-5F40-6280-0F0D-87759344497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F69892-CC1D-D042-B375-BB9394B36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593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ruta 3">
            <a:extLst>
              <a:ext uri="{FF2B5EF4-FFF2-40B4-BE49-F238E27FC236}">
                <a16:creationId xmlns:a16="http://schemas.microsoft.com/office/drawing/2014/main" id="{0AEDBE2C-0AAC-BA12-DE31-1173140E1612}"/>
              </a:ext>
            </a:extLst>
          </p:cNvPr>
          <p:cNvSpPr txBox="1"/>
          <p:nvPr/>
        </p:nvSpPr>
        <p:spPr>
          <a:xfrm>
            <a:off x="1036024" y="416937"/>
            <a:ext cx="3274540" cy="537904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99 620 men diagnosed with prostate cancer 2000-2020</a:t>
            </a:r>
            <a:endParaRPr lang="sv-SE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textruta 4">
            <a:extLst>
              <a:ext uri="{FF2B5EF4-FFF2-40B4-BE49-F238E27FC236}">
                <a16:creationId xmlns:a16="http://schemas.microsoft.com/office/drawing/2014/main" id="{0B2E8CAD-C699-D36B-6DD4-50DA068C4D1F}"/>
              </a:ext>
            </a:extLst>
          </p:cNvPr>
          <p:cNvSpPr txBox="1"/>
          <p:nvPr/>
        </p:nvSpPr>
        <p:spPr>
          <a:xfrm>
            <a:off x="1036015" y="2559039"/>
            <a:ext cx="3274540" cy="553357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80 632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n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agnosed with complete information</a:t>
            </a:r>
            <a:endParaRPr lang="sv-SE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textruta 6">
            <a:extLst>
              <a:ext uri="{FF2B5EF4-FFF2-40B4-BE49-F238E27FC236}">
                <a16:creationId xmlns:a16="http://schemas.microsoft.com/office/drawing/2014/main" id="{A9817430-B435-FAC7-B89B-CE6EC57096D2}"/>
              </a:ext>
            </a:extLst>
          </p:cNvPr>
          <p:cNvSpPr txBox="1"/>
          <p:nvPr/>
        </p:nvSpPr>
        <p:spPr>
          <a:xfrm>
            <a:off x="5389711" y="826158"/>
            <a:ext cx="4471389" cy="1639808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cluded: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0 853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n without Gleason score recorded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8 114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n with missing (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r wrong) GG1+GG2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0 men with negative follow up time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 man with clinical diagnosis only</a:t>
            </a:r>
          </a:p>
        </p:txBody>
      </p:sp>
      <p:cxnSp>
        <p:nvCxnSpPr>
          <p:cNvPr id="9" name="Rak 8">
            <a:extLst>
              <a:ext uri="{FF2B5EF4-FFF2-40B4-BE49-F238E27FC236}">
                <a16:creationId xmlns:a16="http://schemas.microsoft.com/office/drawing/2014/main" id="{F009D45A-DE48-B86D-293D-FEC26E817C5E}"/>
              </a:ext>
            </a:extLst>
          </p:cNvPr>
          <p:cNvCxnSpPr>
            <a:cxnSpLocks/>
            <a:endCxn id="5" idx="0"/>
          </p:cNvCxnSpPr>
          <p:nvPr/>
        </p:nvCxnSpPr>
        <p:spPr>
          <a:xfrm>
            <a:off x="2667107" y="955555"/>
            <a:ext cx="6178" cy="160348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ruta 9">
            <a:extLst>
              <a:ext uri="{FF2B5EF4-FFF2-40B4-BE49-F238E27FC236}">
                <a16:creationId xmlns:a16="http://schemas.microsoft.com/office/drawing/2014/main" id="{D5F743CC-CEE8-7C56-92A2-80D3F84B5478}"/>
              </a:ext>
            </a:extLst>
          </p:cNvPr>
          <p:cNvSpPr txBox="1"/>
          <p:nvPr/>
        </p:nvSpPr>
        <p:spPr>
          <a:xfrm>
            <a:off x="5389709" y="3458481"/>
            <a:ext cx="4471383" cy="307392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8 520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en with T1a/T1b/T1ab/T1x tumors</a:t>
            </a:r>
          </a:p>
        </p:txBody>
      </p:sp>
      <p:sp>
        <p:nvSpPr>
          <p:cNvPr id="11" name="textruta 10">
            <a:extLst>
              <a:ext uri="{FF2B5EF4-FFF2-40B4-BE49-F238E27FC236}">
                <a16:creationId xmlns:a16="http://schemas.microsoft.com/office/drawing/2014/main" id="{F2EF5436-6355-1566-BCC0-F0511E161D21}"/>
              </a:ext>
            </a:extLst>
          </p:cNvPr>
          <p:cNvSpPr txBox="1"/>
          <p:nvPr/>
        </p:nvSpPr>
        <p:spPr>
          <a:xfrm>
            <a:off x="1036015" y="4226914"/>
            <a:ext cx="3274540" cy="553357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72 112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en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 complete information and diagnosed with core needle biopsy</a:t>
            </a:r>
            <a:endParaRPr lang="sv-SE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3" name="Rak 12">
            <a:extLst>
              <a:ext uri="{FF2B5EF4-FFF2-40B4-BE49-F238E27FC236}">
                <a16:creationId xmlns:a16="http://schemas.microsoft.com/office/drawing/2014/main" id="{0893A239-4276-0772-6387-B7F2AD971210}"/>
              </a:ext>
            </a:extLst>
          </p:cNvPr>
          <p:cNvCxnSpPr>
            <a:cxnSpLocks/>
            <a:stCxn id="5" idx="2"/>
          </p:cNvCxnSpPr>
          <p:nvPr/>
        </p:nvCxnSpPr>
        <p:spPr>
          <a:xfrm>
            <a:off x="2673285" y="3112396"/>
            <a:ext cx="0" cy="112916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Rak pil 15">
            <a:extLst>
              <a:ext uri="{FF2B5EF4-FFF2-40B4-BE49-F238E27FC236}">
                <a16:creationId xmlns:a16="http://schemas.microsoft.com/office/drawing/2014/main" id="{21A92125-2594-F1D2-CDA5-AA36C258E3EF}"/>
              </a:ext>
            </a:extLst>
          </p:cNvPr>
          <p:cNvCxnSpPr>
            <a:cxnSpLocks/>
          </p:cNvCxnSpPr>
          <p:nvPr/>
        </p:nvCxnSpPr>
        <p:spPr>
          <a:xfrm flipV="1">
            <a:off x="2667105" y="1793405"/>
            <a:ext cx="2722605" cy="729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Rak pil 18">
            <a:extLst>
              <a:ext uri="{FF2B5EF4-FFF2-40B4-BE49-F238E27FC236}">
                <a16:creationId xmlns:a16="http://schemas.microsoft.com/office/drawing/2014/main" id="{19B25D95-CA0F-09E1-B29F-2F0204A10D2C}"/>
              </a:ext>
            </a:extLst>
          </p:cNvPr>
          <p:cNvCxnSpPr>
            <a:cxnSpLocks/>
          </p:cNvCxnSpPr>
          <p:nvPr/>
        </p:nvCxnSpPr>
        <p:spPr>
          <a:xfrm>
            <a:off x="2667105" y="3642859"/>
            <a:ext cx="272260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ruta 9">
            <a:extLst>
              <a:ext uri="{FF2B5EF4-FFF2-40B4-BE49-F238E27FC236}">
                <a16:creationId xmlns:a16="http://schemas.microsoft.com/office/drawing/2014/main" id="{075DD9F4-34DA-6F75-5401-9EACB4926329}"/>
              </a:ext>
            </a:extLst>
          </p:cNvPr>
          <p:cNvSpPr txBox="1"/>
          <p:nvPr/>
        </p:nvSpPr>
        <p:spPr>
          <a:xfrm>
            <a:off x="5389717" y="5057825"/>
            <a:ext cx="4471383" cy="311496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53 831 men with Gleason score 2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≤ 7 and 9-10</a:t>
            </a:r>
            <a:endParaRPr lang="en-US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7" name="textruta 10">
            <a:extLst>
              <a:ext uri="{FF2B5EF4-FFF2-40B4-BE49-F238E27FC236}">
                <a16:creationId xmlns:a16="http://schemas.microsoft.com/office/drawing/2014/main" id="{1790D78A-8C33-D73F-5D69-94E29987A167}"/>
              </a:ext>
            </a:extLst>
          </p:cNvPr>
          <p:cNvSpPr txBox="1"/>
          <p:nvPr/>
        </p:nvSpPr>
        <p:spPr>
          <a:xfrm>
            <a:off x="1036023" y="5768982"/>
            <a:ext cx="3274540" cy="768415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 281 m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 in study population: men in NPCR registered with Gleason score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8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iagnosed by core needle biopsy</a:t>
            </a:r>
            <a:endParaRPr lang="sv-SE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8" name="Rak 12">
            <a:extLst>
              <a:ext uri="{FF2B5EF4-FFF2-40B4-BE49-F238E27FC236}">
                <a16:creationId xmlns:a16="http://schemas.microsoft.com/office/drawing/2014/main" id="{CA9C0019-8A8F-D898-68B8-B893EF6AC0ED}"/>
              </a:ext>
            </a:extLst>
          </p:cNvPr>
          <p:cNvCxnSpPr>
            <a:cxnSpLocks/>
            <a:endCxn id="17" idx="0"/>
          </p:cNvCxnSpPr>
          <p:nvPr/>
        </p:nvCxnSpPr>
        <p:spPr>
          <a:xfrm>
            <a:off x="2673293" y="4751583"/>
            <a:ext cx="0" cy="101739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Rak pil 18">
            <a:extLst>
              <a:ext uri="{FF2B5EF4-FFF2-40B4-BE49-F238E27FC236}">
                <a16:creationId xmlns:a16="http://schemas.microsoft.com/office/drawing/2014/main" id="{BB7B542D-0460-3880-C5D7-EDB49F8D7574}"/>
              </a:ext>
            </a:extLst>
          </p:cNvPr>
          <p:cNvCxnSpPr>
            <a:cxnSpLocks/>
          </p:cNvCxnSpPr>
          <p:nvPr/>
        </p:nvCxnSpPr>
        <p:spPr>
          <a:xfrm>
            <a:off x="2667114" y="5244312"/>
            <a:ext cx="272260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583877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5</TotalTime>
  <Words>104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ema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Rolf Gedeborg</dc:creator>
  <cp:lastModifiedBy>Chiara Micoli</cp:lastModifiedBy>
  <cp:revision>12</cp:revision>
  <dcterms:created xsi:type="dcterms:W3CDTF">2023-01-26T15:43:07Z</dcterms:created>
  <dcterms:modified xsi:type="dcterms:W3CDTF">2023-09-12T09:41:44Z</dcterms:modified>
</cp:coreProperties>
</file>